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0" autoAdjust="0"/>
    <p:restoredTop sz="94660"/>
  </p:normalViewPr>
  <p:slideViewPr>
    <p:cSldViewPr snapToGrid="0">
      <p:cViewPr varScale="1">
        <p:scale>
          <a:sx n="76" d="100"/>
          <a:sy n="76" d="100"/>
        </p:scale>
        <p:origin x="76" y="3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037B0C9-90CC-33FF-7192-96A423F5EF8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3B170631-7B4A-1D60-9DCF-7966B32EC11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12F45F5-8E7B-205D-15D9-E59BA2B373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42128-B47C-4134-8C91-3FAE17C529FD}" type="datetimeFigureOut">
              <a:rPr lang="de-DE" smtClean="0"/>
              <a:t>16.04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71DC1FD-88EA-ABC5-6868-1CCDE82B9A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987C029-DD05-4C25-9F33-FF9474C3E4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89D235-16C3-4D6B-B91A-B25A65D950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953643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D053721-BD1B-9956-78FA-53A669B0C8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EC003CFC-B837-617C-445E-8C3EAAE6C3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358F158-A1CD-0BE6-40E6-1ECA165E89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42128-B47C-4134-8C91-3FAE17C529FD}" type="datetimeFigureOut">
              <a:rPr lang="de-DE" smtClean="0"/>
              <a:t>16.04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51971D8-AB52-A7C0-8523-8A51E4896A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1E39F15-BE27-ADB0-10C7-800B868FD3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89D235-16C3-4D6B-B91A-B25A65D950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835189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A8B26A57-737E-8B7F-005D-8F2B4FAA357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17DFBDD8-9E31-28A8-A214-35BB69C6E2D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AEDEC2F-91A5-FA4A-837B-6D71A041F9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42128-B47C-4134-8C91-3FAE17C529FD}" type="datetimeFigureOut">
              <a:rPr lang="de-DE" smtClean="0"/>
              <a:t>16.04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D9DE229-B9FE-DCD3-E3FF-A06D106DF5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B7C00F8-F227-8215-A93C-EFB8024709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89D235-16C3-4D6B-B91A-B25A65D950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467131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581F067-9096-24D5-C2B7-A48CB74CA4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8D4AF658-2DF9-D509-278E-305230901F9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CF2C2FC-ECED-2FE4-6314-7E1ACF6C1F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42128-B47C-4134-8C91-3FAE17C529FD}" type="datetimeFigureOut">
              <a:rPr lang="de-DE" smtClean="0"/>
              <a:t>16.04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7FCFFDE-1112-B0FC-E67F-8AA0E25A5C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4885F39-A8D1-52A5-E24D-E2007443A2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89D235-16C3-4D6B-B91A-B25A65D950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802493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7CAEE6A-B292-E0D0-3588-EF9B5C1E06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B51092A4-A24E-B1B6-692B-19B99652DF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1C61001-6985-F9F3-DA94-0879E1A2C3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42128-B47C-4134-8C91-3FAE17C529FD}" type="datetimeFigureOut">
              <a:rPr lang="de-DE" smtClean="0"/>
              <a:t>16.04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600F80A-9337-1474-861C-11F4E923A5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F99CC32-3540-638B-5BA0-2892D5C75D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89D235-16C3-4D6B-B91A-B25A65D950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27075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0D580A6-3F22-3684-21CF-059583B012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3BB714BA-CA13-F5FD-E3F3-4C22C73F086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BA174B27-C430-F787-64BD-3BBB1AD76D2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9759086C-DDE5-A9DA-D714-91B7C00693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42128-B47C-4134-8C91-3FAE17C529FD}" type="datetimeFigureOut">
              <a:rPr lang="de-DE" smtClean="0"/>
              <a:t>16.04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B0E8ACA7-6B43-9C72-0474-D7DC983747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47E25489-9613-8B60-10F6-37ABEE9509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89D235-16C3-4D6B-B91A-B25A65D950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416916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8F63D44-D3C9-F311-0D1E-104DAC24B2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07D32198-B700-7EF3-4401-21A3932A74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4BB91E4D-D9E0-D8B1-0726-0751D1B0C9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278600CC-7087-CB28-C322-9ECF92056AA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83396A40-A995-B5A0-3716-1C5B136BFDE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940F7AFB-9E70-8F85-AD32-A325C81D47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42128-B47C-4134-8C91-3FAE17C529FD}" type="datetimeFigureOut">
              <a:rPr lang="de-DE" smtClean="0"/>
              <a:t>16.04.2023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84ECE1D0-2159-47E3-8B51-A8A269A722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072170ED-BB37-32C9-8A8C-28C5017193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89D235-16C3-4D6B-B91A-B25A65D950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081207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B4C9C0A-89DD-9995-4604-8916F29D5A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1667708A-1DEC-76D5-79C6-B9A70C1539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42128-B47C-4134-8C91-3FAE17C529FD}" type="datetimeFigureOut">
              <a:rPr lang="de-DE" smtClean="0"/>
              <a:t>16.04.2023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D0720167-8760-E54E-D579-A6CA85995A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5D2A1081-9F5A-66FC-ED8D-2F09575504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89D235-16C3-4D6B-B91A-B25A65D950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724052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F3A45AFE-D0C3-79A2-B35B-3E85167F6C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42128-B47C-4134-8C91-3FAE17C529FD}" type="datetimeFigureOut">
              <a:rPr lang="de-DE" smtClean="0"/>
              <a:t>16.04.2023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3483EFB9-8584-403E-96F9-C08535D4C2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54578EFB-0AEB-34A4-FA36-25E8A29617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89D235-16C3-4D6B-B91A-B25A65D950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903022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ADABB3C-6BCE-D485-EF91-B48671EF21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11851A6A-27F3-B0BD-9D35-0155914B824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5D3B8ED9-F16B-CB6F-424E-6FD71369CD7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110F3DBE-34ED-47EB-8A81-B6CA2AD2D7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42128-B47C-4134-8C91-3FAE17C529FD}" type="datetimeFigureOut">
              <a:rPr lang="de-DE" smtClean="0"/>
              <a:t>16.04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3734A035-8E41-CA96-161F-698F969510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7FD4711A-5E3A-5BE5-EF3C-83ED5C80B0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89D235-16C3-4D6B-B91A-B25A65D950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987220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474FA7E-BA0E-6D92-95F6-27A178A6B1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23F44768-EF7B-25C6-2853-E06D98314AD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D355C827-FEF0-D0F3-E4D1-F6313B08634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3400E398-5F08-70C2-556B-4D9F833377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42128-B47C-4134-8C91-3FAE17C529FD}" type="datetimeFigureOut">
              <a:rPr lang="de-DE" smtClean="0"/>
              <a:t>16.04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19A9D02F-2290-7396-68FD-9BD21B8BCA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4E6E7E33-CF1A-C4D3-98D6-8DB1098B2D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89D235-16C3-4D6B-B91A-B25A65D950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323933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6E665F57-209D-2195-654D-21A9AEFC3C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E4DAAAF5-00F6-CCCD-C029-B956DD8D06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35B8E4F-EDCA-00B1-FE8E-0C97B36D844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142128-B47C-4134-8C91-3FAE17C529FD}" type="datetimeFigureOut">
              <a:rPr lang="de-DE" smtClean="0"/>
              <a:t>16.04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07D45DA-7510-8824-965B-2AD3E197170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0711744-FC1E-C21E-19DA-523C0512D65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89D235-16C3-4D6B-B91A-B25A65D950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109501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>
            <a:extLst>
              <a:ext uri="{FF2B5EF4-FFF2-40B4-BE49-F238E27FC236}">
                <a16:creationId xmlns:a16="http://schemas.microsoft.com/office/drawing/2014/main" id="{40B684F0-C7DE-6466-0CBE-691BB652C04E}"/>
              </a:ext>
            </a:extLst>
          </p:cNvPr>
          <p:cNvSpPr txBox="1"/>
          <p:nvPr/>
        </p:nvSpPr>
        <p:spPr>
          <a:xfrm>
            <a:off x="2012167" y="5343307"/>
            <a:ext cx="8167664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2. Depression, Anxiety, Fatigue and Stress at the 12-month follow-up.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patient health questionnaire-9 (PHQ-9) was used to measure depression. Generalized anxiety disorder 7 (GAD-7) was used for screening of a generalized anxiety disorder. Individual’s level of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atigue was assessed with the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ACIT fatigue scale. Stress assessment was done with the perceived stress scale (PSS-10) and the posttraumatic symptom scale 10 (PTSS-10). All individual patient values are displayed as a single data point. Furthermore, the median line ± interquartile range are displayed.PHQ-9 medians significantly differed with a higher score in ICU patients, whereas in both groups medians were well below the cutoff-value ≥10 for detecting a major depressive disorder. Medians of GAD-7, FACIT-F or PSS-10 and PTSS-10 were not significantly different, and all medians were under the cutoff-values of a pathologic state, respectively.</a:t>
            </a:r>
            <a:endParaRPr lang="de-DE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" name="Gruppieren 6">
            <a:extLst>
              <a:ext uri="{FF2B5EF4-FFF2-40B4-BE49-F238E27FC236}">
                <a16:creationId xmlns:a16="http://schemas.microsoft.com/office/drawing/2014/main" id="{B0F18C3C-911B-0606-65A0-B412FD33E362}"/>
              </a:ext>
            </a:extLst>
          </p:cNvPr>
          <p:cNvGrpSpPr/>
          <p:nvPr/>
        </p:nvGrpSpPr>
        <p:grpSpPr>
          <a:xfrm>
            <a:off x="2012167" y="0"/>
            <a:ext cx="8167664" cy="5343307"/>
            <a:chOff x="2012167" y="0"/>
            <a:chExt cx="8167664" cy="5343307"/>
          </a:xfrm>
        </p:grpSpPr>
        <p:pic>
          <p:nvPicPr>
            <p:cNvPr id="5" name="Grafik 4">
              <a:extLst>
                <a:ext uri="{FF2B5EF4-FFF2-40B4-BE49-F238E27FC236}">
                  <a16:creationId xmlns:a16="http://schemas.microsoft.com/office/drawing/2014/main" id="{BAB7B0A7-C4AA-06A4-247A-6FC32F8451C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35816" y="0"/>
              <a:ext cx="7720367" cy="5343307"/>
            </a:xfrm>
            <a:prstGeom prst="rect">
              <a:avLst/>
            </a:prstGeom>
            <a:solidFill>
              <a:schemeClr val="bg1">
                <a:alpha val="0"/>
              </a:schemeClr>
            </a:solidFill>
          </p:spPr>
        </p:pic>
        <p:sp>
          <p:nvSpPr>
            <p:cNvPr id="2" name="Rechteck 1">
              <a:extLst>
                <a:ext uri="{FF2B5EF4-FFF2-40B4-BE49-F238E27FC236}">
                  <a16:creationId xmlns:a16="http://schemas.microsoft.com/office/drawing/2014/main" id="{6B777796-49A3-06B7-9D7A-ABBFC3C1F787}"/>
                </a:ext>
              </a:extLst>
            </p:cNvPr>
            <p:cNvSpPr/>
            <p:nvPr/>
          </p:nvSpPr>
          <p:spPr>
            <a:xfrm>
              <a:off x="2012167" y="2624537"/>
              <a:ext cx="8167664" cy="14658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" name="Rechteck 2">
              <a:extLst>
                <a:ext uri="{FF2B5EF4-FFF2-40B4-BE49-F238E27FC236}">
                  <a16:creationId xmlns:a16="http://schemas.microsoft.com/office/drawing/2014/main" id="{1F6175E3-1E50-FBF4-8A03-3E2863721D49}"/>
                </a:ext>
              </a:extLst>
            </p:cNvPr>
            <p:cNvSpPr/>
            <p:nvPr/>
          </p:nvSpPr>
          <p:spPr>
            <a:xfrm>
              <a:off x="4369473" y="0"/>
              <a:ext cx="588421" cy="269286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4" name="Rechteck 3">
              <a:extLst>
                <a:ext uri="{FF2B5EF4-FFF2-40B4-BE49-F238E27FC236}">
                  <a16:creationId xmlns:a16="http://schemas.microsoft.com/office/drawing/2014/main" id="{EA1008BA-DDCF-E84D-701C-A7526D66158C}"/>
                </a:ext>
              </a:extLst>
            </p:cNvPr>
            <p:cNvSpPr/>
            <p:nvPr/>
          </p:nvSpPr>
          <p:spPr>
            <a:xfrm>
              <a:off x="6868617" y="0"/>
              <a:ext cx="588421" cy="269286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dirty="0"/>
            </a:p>
          </p:txBody>
        </p:sp>
      </p:grpSp>
    </p:spTree>
    <p:extLst>
      <p:ext uri="{BB962C8B-B14F-4D97-AF65-F5344CB8AC3E}">
        <p14:creationId xmlns:p14="http://schemas.microsoft.com/office/powerpoint/2010/main" val="26546646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0</Words>
  <Application>Microsoft Office PowerPoint</Application>
  <PresentationFormat>Breitbild</PresentationFormat>
  <Paragraphs>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Johannes Herrmann</dc:creator>
  <cp:lastModifiedBy>Johannes Herrmann</cp:lastModifiedBy>
  <cp:revision>2</cp:revision>
  <dcterms:created xsi:type="dcterms:W3CDTF">2023-04-16T20:01:39Z</dcterms:created>
  <dcterms:modified xsi:type="dcterms:W3CDTF">2023-04-16T20:12:26Z</dcterms:modified>
</cp:coreProperties>
</file>